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72" r:id="rId2"/>
    <p:sldId id="271" r:id="rId3"/>
    <p:sldId id="278" r:id="rId4"/>
    <p:sldId id="273" r:id="rId5"/>
    <p:sldId id="277" r:id="rId6"/>
    <p:sldId id="280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989" autoAdjust="0"/>
    <p:restoredTop sz="94660"/>
  </p:normalViewPr>
  <p:slideViewPr>
    <p:cSldViewPr snapToGrid="0">
      <p:cViewPr varScale="1">
        <p:scale>
          <a:sx n="87" d="100"/>
          <a:sy n="87" d="100"/>
        </p:scale>
        <p:origin x="2838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1C3BFE-6FA9-4A23-B718-B38178AD576E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F6E418-0D95-4AFE-9FA3-D4313C471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97321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7148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0368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7032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3943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2082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014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3391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741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3975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107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5653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629786-D360-48AC-9EB1-0518D398ED42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149352-4B33-4BE2-B529-8E9D69287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9534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1886585" y="5173250"/>
          <a:ext cx="3084830" cy="323088"/>
        </p:xfrm>
        <a:graphic>
          <a:graphicData uri="http://schemas.openxmlformats.org/drawingml/2006/table">
            <a:tbl>
              <a:tblPr firstRow="1" firstCol="1" bandRow="1"/>
              <a:tblGrid>
                <a:gridCol w="308483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/>
                      </a:r>
                      <a:br>
                        <a:rPr lang="en-US" sz="1000" kern="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</a:br>
                      <a:r>
                        <a:rPr lang="en-US" sz="1000" kern="100" baseline="300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endParaRPr lang="en-GB" sz="12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2729318"/>
              </p:ext>
            </p:extLst>
          </p:nvPr>
        </p:nvGraphicFramePr>
        <p:xfrm>
          <a:off x="1218487" y="1611303"/>
          <a:ext cx="4557395" cy="5254625"/>
        </p:xfrm>
        <a:graphic>
          <a:graphicData uri="http://schemas.openxmlformats.org/drawingml/2006/table">
            <a:tbl>
              <a:tblPr bandRow="1"/>
              <a:tblGrid>
                <a:gridCol w="153352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302387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</a:tblGrid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Gene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Sequence (5' to 3')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Atrogin-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F: CACATTCTCTCCTGGAAGGGC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 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R: TTGATAAAGTCTTGAGGGGAA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MuRF-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F: TGAGGTGCCTACTTGCTCCT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 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R: TCACCTGGTGGCTATTCTCC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LC3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F: 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AGCAGCATCCAACCAAAATC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 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R: 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CTGTGTCCGTTCACCAACAG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p62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F: 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CCATGTCCTACGTGAAGGATGA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 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R: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CCGCCGGCACTCTTTTT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IGF-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F: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TCAACAAGCCCACAGGCTATG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 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R: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AGTACATCTCCAGTCTCCTCAGATCA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GAPDH</a:t>
                      </a: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F: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CTCCACTCACGGCAAATTCA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72812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smtClean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smtClean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MYH7</a:t>
                      </a: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 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R: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GCCTCACCCCATTTGATGTT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F: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GATCACCACGAACCCATATGATT 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R: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TTCATGTTCCCATAATGCATCAC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 smtClean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3092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 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 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1335602" y="1026528"/>
            <a:ext cx="5394523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able S</a:t>
            </a:r>
            <a:r>
              <a:rPr lang="en-US" altLang="zh-CN" sz="16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altLang="zh-CN" sz="1600" b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: </a:t>
            </a:r>
            <a:r>
              <a:rPr lang="en-US" altLang="zh-CN" sz="16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rimer sequences used in this study. </a:t>
            </a:r>
            <a:r>
              <a:rPr kumimoji="0" lang="en-US" altLang="zh-CN" sz="1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endParaRPr kumimoji="0" lang="en-GB" altLang="zh-CN" sz="1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zh-CN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3211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6837608"/>
              </p:ext>
            </p:extLst>
          </p:nvPr>
        </p:nvGraphicFramePr>
        <p:xfrm>
          <a:off x="2233836" y="118583"/>
          <a:ext cx="4406302" cy="9246327"/>
        </p:xfrm>
        <a:graphic>
          <a:graphicData uri="http://schemas.openxmlformats.org/drawingml/2006/table">
            <a:tbl>
              <a:tblPr firstRow="1" firstCol="1" bandRow="1"/>
              <a:tblGrid>
                <a:gridCol w="80361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801343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18811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88253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Pos.</a:t>
                      </a:r>
                      <a:endParaRPr lang="en-GB" sz="1000" kern="1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l-GR" sz="1000" i="1" kern="100" dirty="0">
                          <a:effectLst/>
                          <a:latin typeface="Century" panose="02040604050505020304" pitchFamily="18" charset="0"/>
                          <a:ea typeface="Malgun Gothic" panose="020B0503020000020004" pitchFamily="34" charset="-127"/>
                        </a:rPr>
                        <a:t>δ</a:t>
                      </a:r>
                      <a:r>
                        <a:rPr lang="en-US" sz="1000" kern="100" baseline="-250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H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(</a:t>
                      </a:r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mult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., </a:t>
                      </a:r>
                      <a:r>
                        <a:rPr lang="en-US" sz="1000" i="1" kern="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J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in Hz) </a:t>
                      </a:r>
                      <a:r>
                        <a:rPr lang="en-US" sz="1000" kern="100" baseline="30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</a:t>
                      </a:r>
                      <a:endParaRPr lang="en-GB" sz="1000" kern="1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l-GR" altLang="ko-KR" sz="1000" i="1" kern="100" dirty="0">
                          <a:effectLst/>
                          <a:latin typeface="Century" panose="02040604050505020304" pitchFamily="18" charset="0"/>
                          <a:ea typeface="Malgun Gothic" panose="020B0503020000020004" pitchFamily="34" charset="-127"/>
                        </a:rPr>
                        <a:t>δ</a:t>
                      </a:r>
                      <a:r>
                        <a:rPr lang="en-US" sz="1000" kern="100" baseline="-25000" dirty="0" err="1">
                          <a:effectLst/>
                          <a:latin typeface="Century" panose="02040604050505020304" pitchFamily="18" charset="0"/>
                          <a:ea typeface="Malgun Gothic" panose="020B0503020000020004" pitchFamily="34" charset="-127"/>
                        </a:rPr>
                        <a:t>C</a:t>
                      </a:r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,</a:t>
                      </a:r>
                      <a:r>
                        <a:rPr lang="en-US" sz="1000" kern="100" baseline="30000" dirty="0" err="1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b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type</a:t>
                      </a:r>
                      <a:endParaRPr lang="en-GB" sz="1000" kern="1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39, m</a:t>
                      </a:r>
                      <a:b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0.88, m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9.2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.18, m</a:t>
                      </a:r>
                      <a:b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88, d (2.3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7.0,</a:t>
                      </a:r>
                      <a:endParaRPr lang="en-GB" sz="1000" kern="1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.37, </a:t>
                      </a:r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d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 (11.6, 4.2)</a:t>
                      </a:r>
                      <a:endParaRPr lang="en-GB" sz="1000" kern="1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89.7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6.7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0.79, d (7.3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6.0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6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51, d (13.0)</a:t>
                      </a:r>
                      <a:b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33 (br s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9.7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7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34, m</a:t>
                      </a:r>
                      <a:b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59, d (2.8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3.3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8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0.7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9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60, m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7.5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0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7.6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1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84, m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4.5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.36, d (4.0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24.5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43.0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=C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4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3.5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29478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5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.18, m</a:t>
                      </a:r>
                      <a:b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74, dd (11.3, 4.8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7.2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6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.11, dd (11.3, 5.0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66.0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7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0.0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7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8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.03, dd (13.9, 5.8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4.5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8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9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.10, br s</a:t>
                      </a:r>
                      <a:b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23, m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6.4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9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0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2.8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0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1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.00, d (10.7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9.8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1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6.36, dd (10.5, 5.4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74.1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2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01, s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7.4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3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4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31, s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8.0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4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5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0.81, s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6.1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5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6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0.95, s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7.4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6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7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47, s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8.5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7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8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.07, s</a:t>
                      </a:r>
                      <a:b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</a:b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.51, d (10.6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60.3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8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9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28, s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6.0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9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0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01, s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3.7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30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68.9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OO</a:t>
                      </a:r>
                      <a:r>
                        <a:rPr lang="en-US" sz="1000" kern="100" baseline="30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-</a:t>
                      </a:r>
                      <a:endParaRPr lang="en-GB" sz="1000" kern="100" baseline="300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31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12.6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32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52.3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-N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33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6.66, dd (8.0, 5.7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11.9, 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34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7.40, ddd (8.7, 7.0, 1.6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35.1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35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6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6.66, dd (8.0, 5.7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15.1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36"/>
                  </a:ext>
                </a:extLst>
              </a:tr>
              <a:tr h="19432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7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8.47, dd (8.1, 1.5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33.4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37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8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.80, s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0.1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r>
                        <a:rPr lang="en-US" sz="1000" kern="100" baseline="-25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38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'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.03, d (7.7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07.2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39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'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.18, d (8.4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74.7, 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40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3'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.37, d (4.9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87.8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41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'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.56, m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71.9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42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'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.69, d (9.6)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77.2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H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43"/>
                  </a:ext>
                </a:extLst>
              </a:tr>
              <a:tr h="93862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6''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70.7,</a:t>
                      </a:r>
                      <a:endParaRPr lang="en-GB" sz="1000" kern="1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OO</a:t>
                      </a:r>
                      <a:r>
                        <a:rPr lang="en-US" sz="1000" kern="100" baseline="30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-</a:t>
                      </a:r>
                      <a:endParaRPr lang="en-GB" sz="1000" kern="100" baseline="300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44"/>
                  </a:ext>
                </a:extLst>
              </a:tr>
              <a:tr h="551019">
                <a:tc gridSpan="4"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kern="100" baseline="30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 Recorded in pyridine – </a:t>
                      </a:r>
                      <a:r>
                        <a:rPr lang="en-US" sz="1000" i="1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</a:t>
                      </a:r>
                      <a:r>
                        <a:rPr lang="en-US" sz="1000" kern="100" baseline="-25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 at 400 MHz</a:t>
                      </a:r>
                      <a:r>
                        <a:rPr lang="en-US" sz="1000" kern="100" dirty="0">
                          <a:effectLst/>
                          <a:latin typeface="Malgun Gothic" panose="020B0503020000020004" pitchFamily="34" charset="-127"/>
                          <a:ea typeface="Malgun Gothic" panose="020B0503020000020004" pitchFamily="34" charset="-127"/>
                        </a:rPr>
                        <a:t>;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 </a:t>
                      </a:r>
                      <a:r>
                        <a:rPr lang="en-US" sz="1000" i="1" kern="100" baseline="300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b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 Recorded in pyridine – </a:t>
                      </a:r>
                      <a:r>
                        <a:rPr lang="en-US" sz="1000" i="1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d</a:t>
                      </a:r>
                      <a:r>
                        <a:rPr lang="en-US" sz="1000" kern="100" baseline="-25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5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 at 100 </a:t>
                      </a:r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Hz.</a:t>
                      </a:r>
                      <a:endParaRPr lang="en-GB" sz="1000" kern="1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35361" marR="3536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45"/>
                  </a:ext>
                </a:extLst>
              </a:tr>
            </a:tbl>
          </a:graphicData>
        </a:graphic>
      </p:graphicFrame>
      <p:sp>
        <p:nvSpPr>
          <p:cNvPr id="6" name="Rectangle 2"/>
          <p:cNvSpPr>
            <a:spLocks noChangeArrowheads="1"/>
          </p:cNvSpPr>
          <p:nvPr/>
        </p:nvSpPr>
        <p:spPr bwMode="auto">
          <a:xfrm>
            <a:off x="29655" y="941762"/>
            <a:ext cx="1654002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able S2:</a:t>
            </a:r>
            <a:r>
              <a:rPr lang="en-US" altLang="zh-CN" sz="1600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altLang="zh-CN" sz="16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altLang="zh-CN" sz="16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H and </a:t>
            </a:r>
            <a:r>
              <a:rPr lang="en-US" altLang="zh-CN" sz="16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3</a:t>
            </a:r>
            <a:r>
              <a:rPr lang="en-US" altLang="zh-CN" sz="16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 NMR data of </a:t>
            </a:r>
            <a:r>
              <a:rPr lang="en-US" altLang="zh-CN" sz="16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ymnemantoside</a:t>
            </a:r>
            <a:r>
              <a:rPr lang="en-US" altLang="zh-CN" sz="16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 isolated from </a:t>
            </a:r>
            <a:r>
              <a:rPr lang="en-US" altLang="zh-CN" sz="1600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. </a:t>
            </a:r>
            <a:r>
              <a:rPr lang="en-US" altLang="zh-CN" sz="1600" i="1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nodorum</a:t>
            </a:r>
            <a:r>
              <a:rPr lang="en-US" altLang="zh-CN" sz="1600" i="1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</a:t>
            </a:r>
            <a:endParaRPr kumimoji="0" lang="en-GB" altLang="zh-CN" sz="16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zh-CN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38564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="" xmlns:a16="http://schemas.microsoft.com/office/drawing/2014/main" id="{4BB68FAA-6996-6D85-C413-C5F6A03F97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2">
            <a:extLst>
              <a:ext uri="{FF2B5EF4-FFF2-40B4-BE49-F238E27FC236}">
                <a16:creationId xmlns="" xmlns:a16="http://schemas.microsoft.com/office/drawing/2014/main" id="{CA375FA7-19E8-7EBC-1FE7-A9C8C5F82E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781" y="724575"/>
            <a:ext cx="5879684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able S3: </a:t>
            </a:r>
            <a:r>
              <a:rPr kumimoji="0" lang="en-US" altLang="zh-CN" sz="1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alibration and validation parameters for the HPLC-UV quantification of </a:t>
            </a:r>
            <a:r>
              <a:rPr kumimoji="0" lang="en-US" altLang="zh-CN" sz="160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ymnemantoside</a:t>
            </a:r>
            <a:r>
              <a:rPr kumimoji="0" lang="en-US" altLang="zh-CN" sz="1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 </a:t>
            </a:r>
            <a:endParaRPr kumimoji="0" lang="en-GB" altLang="zh-CN" sz="1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표 2">
            <a:extLst>
              <a:ext uri="{FF2B5EF4-FFF2-40B4-BE49-F238E27FC236}">
                <a16:creationId xmlns="" xmlns:a16="http://schemas.microsoft.com/office/drawing/2014/main" id="{D982AF76-B4A0-1E72-4F57-F6B02DBAF9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9641888"/>
              </p:ext>
            </p:extLst>
          </p:nvPr>
        </p:nvGraphicFramePr>
        <p:xfrm>
          <a:off x="349381" y="1430042"/>
          <a:ext cx="5778084" cy="2348206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429629">
                  <a:extLst>
                    <a:ext uri="{9D8B030D-6E8A-4147-A177-3AD203B41FA5}">
                      <a16:colId xmlns="" xmlns:a16="http://schemas.microsoft.com/office/drawing/2014/main" val="2662604545"/>
                    </a:ext>
                  </a:extLst>
                </a:gridCol>
                <a:gridCol w="1294814">
                  <a:extLst>
                    <a:ext uri="{9D8B030D-6E8A-4147-A177-3AD203B41FA5}">
                      <a16:colId xmlns="" xmlns:a16="http://schemas.microsoft.com/office/drawing/2014/main" val="236228920"/>
                    </a:ext>
                  </a:extLst>
                </a:gridCol>
                <a:gridCol w="1701580">
                  <a:extLst>
                    <a:ext uri="{9D8B030D-6E8A-4147-A177-3AD203B41FA5}">
                      <a16:colId xmlns="" xmlns:a16="http://schemas.microsoft.com/office/drawing/2014/main" val="4017362255"/>
                    </a:ext>
                  </a:extLst>
                </a:gridCol>
                <a:gridCol w="1352061">
                  <a:extLst>
                    <a:ext uri="{9D8B030D-6E8A-4147-A177-3AD203B41FA5}">
                      <a16:colId xmlns="" xmlns:a16="http://schemas.microsoft.com/office/drawing/2014/main" val="399455322"/>
                    </a:ext>
                  </a:extLst>
                </a:gridCol>
              </a:tblGrid>
              <a:tr h="3354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 % 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3770893384"/>
                  </a:ext>
                </a:extLst>
              </a:tr>
              <a:tr h="3354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ope (m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90.8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68.4 - 1813.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ea · mL mg-¹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3928207260"/>
                  </a:ext>
                </a:extLst>
              </a:tr>
              <a:tr h="3354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cept (b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7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 Semilight" panose="020B0502040204020203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ea count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3423516620"/>
                  </a:ext>
                </a:extLst>
              </a:tr>
              <a:tr h="3354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100" u="none" strike="noStrike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 Semilight" panose="020B0502040204020203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 Semilight" panose="020B0502040204020203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3127620884"/>
                  </a:ext>
                </a:extLst>
              </a:tr>
              <a:tr h="3354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</a:t>
                      </a:r>
                      <a:r>
                        <a:rPr lang="el-G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σ</a:t>
                      </a:r>
                      <a:endParaRPr lang="el-G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 Semilight" panose="020B0502040204020203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ea count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1127616474"/>
                  </a:ext>
                </a:extLst>
              </a:tr>
              <a:tr h="3354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 Semilight" panose="020B0502040204020203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 mL-¹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2115291199"/>
                  </a:ext>
                </a:extLst>
              </a:tr>
              <a:tr h="3354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4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­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algun Gothic Semilight" panose="020B0502040204020203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 mL-¹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4196120374"/>
                  </a:ext>
                </a:extLst>
              </a:tr>
            </a:tbl>
          </a:graphicData>
        </a:graphic>
      </p:graphicFrame>
      <p:graphicFrame>
        <p:nvGraphicFramePr>
          <p:cNvPr id="4" name="표 3">
            <a:extLst>
              <a:ext uri="{FF2B5EF4-FFF2-40B4-BE49-F238E27FC236}">
                <a16:creationId xmlns="" xmlns:a16="http://schemas.microsoft.com/office/drawing/2014/main" id="{59DFD19D-4168-B5BF-6CA0-E0D83DB08E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3510943"/>
              </p:ext>
            </p:extLst>
          </p:nvPr>
        </p:nvGraphicFramePr>
        <p:xfrm>
          <a:off x="349381" y="4823151"/>
          <a:ext cx="5778085" cy="175545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019662">
                  <a:extLst>
                    <a:ext uri="{9D8B030D-6E8A-4147-A177-3AD203B41FA5}">
                      <a16:colId xmlns="" xmlns:a16="http://schemas.microsoft.com/office/drawing/2014/main" val="2450160970"/>
                    </a:ext>
                  </a:extLst>
                </a:gridCol>
                <a:gridCol w="1340667">
                  <a:extLst>
                    <a:ext uri="{9D8B030D-6E8A-4147-A177-3AD203B41FA5}">
                      <a16:colId xmlns="" xmlns:a16="http://schemas.microsoft.com/office/drawing/2014/main" val="573231752"/>
                    </a:ext>
                  </a:extLst>
                </a:gridCol>
                <a:gridCol w="1019662">
                  <a:extLst>
                    <a:ext uri="{9D8B030D-6E8A-4147-A177-3AD203B41FA5}">
                      <a16:colId xmlns="" xmlns:a16="http://schemas.microsoft.com/office/drawing/2014/main" val="353305113"/>
                    </a:ext>
                  </a:extLst>
                </a:gridCol>
                <a:gridCol w="1378432">
                  <a:extLst>
                    <a:ext uri="{9D8B030D-6E8A-4147-A177-3AD203B41FA5}">
                      <a16:colId xmlns="" xmlns:a16="http://schemas.microsoft.com/office/drawing/2014/main" val="3111644540"/>
                    </a:ext>
                  </a:extLst>
                </a:gridCol>
                <a:gridCol w="1019662">
                  <a:extLst>
                    <a:ext uri="{9D8B030D-6E8A-4147-A177-3AD203B41FA5}">
                      <a16:colId xmlns="" xmlns:a16="http://schemas.microsoft.com/office/drawing/2014/main" val="1950924845"/>
                    </a:ext>
                  </a:extLst>
                </a:gridCol>
              </a:tblGrid>
              <a:tr h="3510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±S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%RS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 % CI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mark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2875192740"/>
                  </a:ext>
                </a:extLst>
              </a:tr>
              <a:tr h="3510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—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—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526255650"/>
                  </a:ext>
                </a:extLst>
              </a:tr>
              <a:tr h="3510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 ±0.00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–0.004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LO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1707556720"/>
                  </a:ext>
                </a:extLst>
              </a:tr>
              <a:tr h="3510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7 ±0.00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2–0.082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fie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2637390816"/>
                  </a:ext>
                </a:extLst>
              </a:tr>
              <a:tr h="3510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—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—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/>
                </a:tc>
                <a:extLst>
                  <a:ext uri="{0D108BD9-81ED-4DB2-BD59-A6C34878D82A}">
                    <a16:rowId xmlns="" xmlns:a16="http://schemas.microsoft.com/office/drawing/2014/main" val="1875655034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="" xmlns:a16="http://schemas.microsoft.com/office/drawing/2014/main" id="{D158FDC4-FA00-D18E-DEBD-8A73657277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1913" y="4117684"/>
            <a:ext cx="6153019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able S4: </a:t>
            </a:r>
            <a:r>
              <a:rPr kumimoji="0" lang="en-US" altLang="zh-CN" sz="1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oncentration of </a:t>
            </a:r>
            <a:r>
              <a:rPr kumimoji="0" lang="en-US" altLang="zh-CN" sz="160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ymnemantoside</a:t>
            </a:r>
            <a:r>
              <a:rPr kumimoji="0" lang="en-US" altLang="zh-CN" sz="1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 detected in sub-fractions Bu1–Bu4 by HPLC-UV analysis </a:t>
            </a:r>
            <a:endParaRPr kumimoji="0" lang="en-GB" altLang="zh-CN" sz="1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82793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153246" y="837813"/>
            <a:ext cx="6308922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able S</a:t>
            </a:r>
            <a:r>
              <a:rPr lang="en-US" altLang="zh-CN" sz="1600" b="1" dirty="0" smtClean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: </a:t>
            </a:r>
            <a:r>
              <a:rPr lang="en-US" altLang="zh-CN" sz="16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olecular docking analysis result</a:t>
            </a:r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between compound and ligands.</a:t>
            </a:r>
            <a:endParaRPr kumimoji="0" lang="en-GB" altLang="zh-CN" sz="1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zh-CN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9001813"/>
              </p:ext>
            </p:extLst>
          </p:nvPr>
        </p:nvGraphicFramePr>
        <p:xfrm>
          <a:off x="465351" y="1602685"/>
          <a:ext cx="5915025" cy="2100559"/>
        </p:xfrm>
        <a:graphic>
          <a:graphicData uri="http://schemas.openxmlformats.org/drawingml/2006/table">
            <a:tbl>
              <a:tblPr/>
              <a:tblGrid>
                <a:gridCol w="1753511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75351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081363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73709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589548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392191">
                <a:tc>
                  <a:txBody>
                    <a:bodyPr/>
                    <a:lstStyle/>
                    <a:p>
                      <a:pPr algn="l"/>
                      <a:endParaRPr lang="en-GB" sz="120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Ligand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Binding Affinity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(Kcal/</a:t>
                      </a:r>
                      <a:r>
                        <a:rPr lang="en-US" sz="1000" kern="1200" dirty="0" err="1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mol</a:t>
                      </a: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)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rmsd/ub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 </a:t>
                      </a:r>
                      <a:r>
                        <a:rPr lang="en-US" sz="1000" kern="1200" dirty="0" err="1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rmsd</a:t>
                      </a: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/</a:t>
                      </a:r>
                      <a:r>
                        <a:rPr lang="en-US" sz="1000" kern="1200" dirty="0" err="1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lb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33928">
                <a:tc rowSpan="2"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Insulin receptor 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&amp; Compound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ir3_Gymnemantoside A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-8.9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0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0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3392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ir3_Gymnemantoside A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-7.9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.898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0.962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33928"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Glucocorticoid receptor &amp; Compound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udc_Gymnemantoside A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4.2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0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0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3392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udc_Gymnemantoside A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25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822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263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33928">
                <a:tc rowSpan="2"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Insulin receptor 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&amp; Standard ligand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ir3_ANP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-8.5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0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0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3392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ir3_ANP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-8.5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3.692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2.16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0265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Glucocorticoid receptor &amp; Standard ligand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udc_DEX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-12.5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0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0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9458" marR="9458" marT="945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465351" y="1369769"/>
            <a:ext cx="5915025" cy="923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/>
            </a:r>
            <a:br>
              <a:rPr kumimoji="0" lang="en-US" altLang="zh-CN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endParaRPr kumimoji="0" lang="en-US" altLang="zh-CN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/>
            </a:r>
            <a:br>
              <a:rPr kumimoji="0" lang="en-US" altLang="zh-CN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endParaRPr kumimoji="0" lang="en-US" altLang="zh-CN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9535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="" xmlns:a16="http://schemas.microsoft.com/office/drawing/2014/main" id="{0353ED30-6731-CF92-3C1A-727819BD641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2">
            <a:extLst>
              <a:ext uri="{FF2B5EF4-FFF2-40B4-BE49-F238E27FC236}">
                <a16:creationId xmlns="" xmlns:a16="http://schemas.microsoft.com/office/drawing/2014/main" id="{06A34672-3B2A-FDA3-C915-C5B4E2CD9B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0032" y="449109"/>
            <a:ext cx="5879684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able S6: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face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smon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onance (SPR) kinetic (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600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600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equilibrium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600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600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inding parameters for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mnemantosid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(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m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reference ligands interacting with the insulin receptor (IR) tyrosine kinase domain and the glucocorticoid receptor (GR) ligand-binding domain (LBD).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6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imum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ponse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U); χ², fit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alit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mean ± SD.</a:t>
            </a:r>
            <a:endParaRPr kumimoji="0" lang="en-GB" altLang="zh-CN" sz="1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2288658"/>
              </p:ext>
            </p:extLst>
          </p:nvPr>
        </p:nvGraphicFramePr>
        <p:xfrm>
          <a:off x="240032" y="2451045"/>
          <a:ext cx="5915025" cy="1716240"/>
        </p:xfrm>
        <a:graphic>
          <a:graphicData uri="http://schemas.openxmlformats.org/drawingml/2006/table">
            <a:tbl>
              <a:tblPr/>
              <a:tblGrid>
                <a:gridCol w="861747"/>
                <a:gridCol w="632915"/>
                <a:gridCol w="722216"/>
                <a:gridCol w="740634"/>
                <a:gridCol w="738960"/>
                <a:gridCol w="738960"/>
                <a:gridCol w="777470"/>
                <a:gridCol w="702123"/>
              </a:tblGrid>
              <a:tr h="343248"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Protein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Ligand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k</a:t>
                      </a:r>
                      <a:r>
                        <a:rPr lang="en-US" sz="900" i="1" kern="1200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a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 (1/Ms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k</a:t>
                      </a:r>
                      <a:r>
                        <a:rPr lang="en-US" sz="900" i="1" kern="1200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d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 (1/s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R</a:t>
                      </a:r>
                      <a:r>
                        <a:rPr lang="en-US" sz="900" kern="1200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max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 (RU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K</a:t>
                      </a:r>
                      <a:r>
                        <a:rPr lang="en-US" sz="900" i="1" kern="1200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A</a:t>
                      </a:r>
                      <a:r>
                        <a:rPr lang="en-US" sz="900" kern="1200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 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(1/M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K</a:t>
                      </a:r>
                      <a:r>
                        <a:rPr lang="en-US" sz="900" i="1" kern="1200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D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 (M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Chi</a:t>
                      </a:r>
                      <a:r>
                        <a:rPr lang="en-US" sz="900" kern="1200" baseline="30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2 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Gulim" panose="020B0600000101010101" pitchFamily="34" charset="-127"/>
                        </a:rPr>
                        <a:t>(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χ²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3248"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Insulin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receptor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GmA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415±77.78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0.006165±0.00163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42.27±4.27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68000±5515.43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4.75±1.20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4.735±0.67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3248"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Insulin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receptor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ANP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05±2.83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0.0396±0.00070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22.5±0.71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2655±21.21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376.00±2.83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.69±0.23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3248"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Glucocorticoid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receptor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GmA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310±28.28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0.005185±0.00023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52.11±3.55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252000±16970.56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3.97±0.26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4.485±0.80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3248"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Glucocorticoid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receptor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Dexamethasone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64±7.07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0.0327±0.003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34.35±6.43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5015±304.06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99.50</a:t>
                      </a:r>
                      <a:r>
                        <a:rPr lang="zh-CN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±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2.00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 latinLnBrk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algun Gothic" panose="020B0503020000020004" pitchFamily="34" charset="-127"/>
                        </a:rPr>
                        <a:t>1.215±0.19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algun Gothic" panose="020B0503020000020004" pitchFamily="34" charset="-127"/>
                      </a:endParaRPr>
                    </a:p>
                  </a:txBody>
                  <a:tcPr marL="60278" marR="6027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908480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="" xmlns:a16="http://schemas.microsoft.com/office/drawing/2014/main" id="{23B8AA95-A0DB-8E7A-91D7-AA8D144A6F8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2">
            <a:extLst>
              <a:ext uri="{FF2B5EF4-FFF2-40B4-BE49-F238E27FC236}">
                <a16:creationId xmlns="" xmlns:a16="http://schemas.microsoft.com/office/drawing/2014/main" id="{F53C68CD-79D6-D952-16B8-620106B8D3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781" y="724575"/>
            <a:ext cx="5879684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able S7: </a:t>
            </a:r>
            <a:r>
              <a:rPr kumimoji="0" lang="en-US" altLang="zh-CN" sz="16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redicted ADME parameters of compound GMA obtained through computational analysis.</a:t>
            </a:r>
            <a:endParaRPr kumimoji="0" lang="en-GB" altLang="zh-CN" sz="16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13">
            <a:extLst>
              <a:ext uri="{FF2B5EF4-FFF2-40B4-BE49-F238E27FC236}">
                <a16:creationId xmlns="" xmlns:a16="http://schemas.microsoft.com/office/drawing/2014/main" id="{8AD4310E-3807-07C3-CC8F-4C18D90CA9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54" y="1413863"/>
            <a:ext cx="6828346" cy="46587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4422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19</TotalTime>
  <Words>827</Words>
  <Application>Microsoft Office PowerPoint</Application>
  <PresentationFormat>On-screen Show (4:3)</PresentationFormat>
  <Paragraphs>36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0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7" baseType="lpstr">
      <vt:lpstr>Gulim</vt:lpstr>
      <vt:lpstr>Malgun Gothic</vt:lpstr>
      <vt:lpstr>Malgun Gothic</vt:lpstr>
      <vt:lpstr>Malgun Gothic Semilight</vt:lpstr>
      <vt:lpstr>宋体</vt:lpstr>
      <vt:lpstr>Arial</vt:lpstr>
      <vt:lpstr>Calibri</vt:lpstr>
      <vt:lpstr>Calibri Light</vt:lpstr>
      <vt:lpstr>Century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n Williams</dc:creator>
  <cp:lastModifiedBy>Darren Williams</cp:lastModifiedBy>
  <cp:revision>213</cp:revision>
  <dcterms:created xsi:type="dcterms:W3CDTF">2024-07-26T13:23:09Z</dcterms:created>
  <dcterms:modified xsi:type="dcterms:W3CDTF">2025-07-28T06:36:15Z</dcterms:modified>
</cp:coreProperties>
</file>